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</p:sldIdLst>
  <p:sldSz cx="6119813" cy="8099425"/>
  <p:notesSz cx="5662613" cy="7642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51" userDrawn="1">
          <p15:clr>
            <a:srgbClr val="A4A3A4"/>
          </p15:clr>
        </p15:guide>
        <p15:guide id="2" pos="192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594" autoAdjust="0"/>
    <p:restoredTop sz="94660"/>
  </p:normalViewPr>
  <p:slideViewPr>
    <p:cSldViewPr>
      <p:cViewPr varScale="1">
        <p:scale>
          <a:sx n="133" d="100"/>
          <a:sy n="133" d="100"/>
        </p:scale>
        <p:origin x="2088" y="138"/>
      </p:cViewPr>
      <p:guideLst>
        <p:guide orient="horz" pos="2551"/>
        <p:guide pos="192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1325531"/>
            <a:ext cx="5201841" cy="2819800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4254073"/>
            <a:ext cx="4589860" cy="1955486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03932-EA21-45EA-9817-314F5CFB8F6D}" type="datetimeFigureOut">
              <a:rPr lang="en-US" smtClean="0"/>
              <a:t>7/1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56215-095D-41DD-A57D-B0180E7C0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29177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03932-EA21-45EA-9817-314F5CFB8F6D}" type="datetimeFigureOut">
              <a:rPr lang="en-US" smtClean="0"/>
              <a:t>7/1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56215-095D-41DD-A57D-B0180E7C0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3870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431220"/>
            <a:ext cx="1319585" cy="686388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431220"/>
            <a:ext cx="3882256" cy="686388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03932-EA21-45EA-9817-314F5CFB8F6D}" type="datetimeFigureOut">
              <a:rPr lang="en-US" smtClean="0"/>
              <a:t>7/1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56215-095D-41DD-A57D-B0180E7C0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73073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03932-EA21-45EA-9817-314F5CFB8F6D}" type="datetimeFigureOut">
              <a:rPr lang="en-US" smtClean="0"/>
              <a:t>7/1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56215-095D-41DD-A57D-B0180E7C0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17759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2019234"/>
            <a:ext cx="5278339" cy="3369135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5420242"/>
            <a:ext cx="5278339" cy="1771749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03932-EA21-45EA-9817-314F5CFB8F6D}" type="datetimeFigureOut">
              <a:rPr lang="en-US" smtClean="0"/>
              <a:t>7/1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56215-095D-41DD-A57D-B0180E7C0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44740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2156097"/>
            <a:ext cx="2600921" cy="513901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2156097"/>
            <a:ext cx="2600921" cy="513901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03932-EA21-45EA-9817-314F5CFB8F6D}" type="datetimeFigureOut">
              <a:rPr lang="en-US" smtClean="0"/>
              <a:t>7/1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56215-095D-41DD-A57D-B0180E7C0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95487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31221"/>
            <a:ext cx="5278339" cy="156551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1985485"/>
            <a:ext cx="2588967" cy="973055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2958540"/>
            <a:ext cx="2588967" cy="435156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1985485"/>
            <a:ext cx="2601718" cy="973055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2958540"/>
            <a:ext cx="2601718" cy="435156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03932-EA21-45EA-9817-314F5CFB8F6D}" type="datetimeFigureOut">
              <a:rPr lang="en-US" smtClean="0"/>
              <a:t>7/15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56215-095D-41DD-A57D-B0180E7C0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44732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03932-EA21-45EA-9817-314F5CFB8F6D}" type="datetimeFigureOut">
              <a:rPr lang="en-US" smtClean="0"/>
              <a:t>7/15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56215-095D-41DD-A57D-B0180E7C0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10093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03932-EA21-45EA-9817-314F5CFB8F6D}" type="datetimeFigureOut">
              <a:rPr lang="en-US" smtClean="0"/>
              <a:t>7/15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56215-095D-41DD-A57D-B0180E7C0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44257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39962"/>
            <a:ext cx="1973799" cy="1889866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1166169"/>
            <a:ext cx="3098155" cy="5755841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29828"/>
            <a:ext cx="1973799" cy="4501556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03932-EA21-45EA-9817-314F5CFB8F6D}" type="datetimeFigureOut">
              <a:rPr lang="en-US" smtClean="0"/>
              <a:t>7/1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56215-095D-41DD-A57D-B0180E7C0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7795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39962"/>
            <a:ext cx="1973799" cy="1889866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1166169"/>
            <a:ext cx="3098155" cy="5755841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29828"/>
            <a:ext cx="1973799" cy="4501556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03932-EA21-45EA-9817-314F5CFB8F6D}" type="datetimeFigureOut">
              <a:rPr lang="en-US" smtClean="0"/>
              <a:t>7/1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F56215-095D-41DD-A57D-B0180E7C0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49213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431221"/>
            <a:ext cx="5278339" cy="156551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2156097"/>
            <a:ext cx="5278339" cy="513901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7506969"/>
            <a:ext cx="1376958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D03932-EA21-45EA-9817-314F5CFB8F6D}" type="datetimeFigureOut">
              <a:rPr lang="en-US" smtClean="0"/>
              <a:t>7/1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7506969"/>
            <a:ext cx="2065437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7506969"/>
            <a:ext cx="1376958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F56215-095D-41DD-A57D-B0180E7C0D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00390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309"/>
          <a:stretch/>
        </p:blipFill>
        <p:spPr>
          <a:xfrm>
            <a:off x="3517106" y="356131"/>
            <a:ext cx="1759510" cy="1542932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6667"/>
          <a:stretch/>
        </p:blipFill>
        <p:spPr>
          <a:xfrm>
            <a:off x="697706" y="392112"/>
            <a:ext cx="2214119" cy="1623687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3947" y="2285206"/>
            <a:ext cx="5193506" cy="5193506"/>
          </a:xfrm>
          <a:prstGeom prst="rect">
            <a:avLst/>
          </a:prstGeom>
        </p:spPr>
      </p:pic>
      <p:sp>
        <p:nvSpPr>
          <p:cNvPr id="11" name="Rectangle 9"/>
          <p:cNvSpPr>
            <a:spLocks noChangeArrowheads="1"/>
          </p:cNvSpPr>
          <p:nvPr/>
        </p:nvSpPr>
        <p:spPr bwMode="auto">
          <a:xfrm>
            <a:off x="69850" y="7470774"/>
            <a:ext cx="5981700" cy="553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 Network characteristics</a:t>
            </a:r>
            <a:r>
              <a:rPr lang="en-US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A. </a:t>
            </a:r>
            <a:r>
              <a:rPr lang="en-US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argets in unique subnetworks</a:t>
            </a:r>
            <a:r>
              <a:rPr lang="en-US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r>
              <a:rPr lang="en-US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ranscription factors in unique subnetworks</a:t>
            </a:r>
            <a:r>
              <a:rPr lang="en-US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r>
              <a:rPr lang="en-US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omparison of network edge weights and FDR with networks generated by randomizing one, or both gene labels.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1906" y="1111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998439" y="1111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1906" y="214670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4654008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6</TotalTime>
  <Words>46</Words>
  <Application>Microsoft Office PowerPoint</Application>
  <PresentationFormat>Custom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GBM-LGG Figures</dc:title>
  <dc:creator>Celiku, Orieta (NIH/NCI) [E]</dc:creator>
  <cp:lastModifiedBy>Celiku, Orieta (NIH/NCI) [E]</cp:lastModifiedBy>
  <cp:revision>42</cp:revision>
  <cp:lastPrinted>2016-07-15T16:41:28Z</cp:lastPrinted>
  <dcterms:created xsi:type="dcterms:W3CDTF">2016-07-15T13:00:09Z</dcterms:created>
  <dcterms:modified xsi:type="dcterms:W3CDTF">2016-07-15T18:30:00Z</dcterms:modified>
</cp:coreProperties>
</file>